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2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2E0B1C-1FEF-21AF-86CC-055F656F30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E866F3F-152D-500B-B445-A674AC9C44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9D854D-EDE9-136B-FBAA-9FA8CA6E96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BCB1F1-E0BA-08DB-3484-076DE6517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E96911-976F-CBD8-3E67-AD805258A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0709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1C0185-B85B-A474-C3F0-861535AF1A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149358C-990A-EB02-DB7F-910B0BED78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6638FC-A9FD-A8F6-14CA-1213F0827B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72BF38-ACD2-0053-3C99-EDCE818D2A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3A425AE-5F2E-FCE0-A2E5-B7ABBCF29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6369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B463AA-68A4-16BE-91D3-5CA00F48A5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8A1307D-293B-13EF-244D-11E1CE1A64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93D01E-16A6-2034-E292-368A7D05EF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C503EB-35EE-AB87-C2CC-1F5B04EBB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65312A-0C7B-0AAB-4086-D75A4DE03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7806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3C1315-66A0-D1F3-E2BC-73DB73AFF7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8919640-9685-28DB-A86A-D40B9AA413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2DFD6C-319B-10BD-8442-9D51710A9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5D5E36-53B2-4F64-0EA6-58810714B9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6ED34C-2CFA-E474-EA1F-0D02C1993C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3116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656CAE-B021-975B-4A06-A1EB85334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F2E09CA-DE7C-9A77-3EF7-633A60E006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9584D6-8587-434B-D27D-38D60121C4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C35207-808C-8119-1716-C9A5B2CCD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E99E9B-39A1-C6B1-0687-888E28279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0833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541489-EEA6-60D7-326B-8A3718778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B9AADAD-3F84-C139-E8D1-D83233F67B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2FA4EE2-5BE6-03E4-8193-A038428185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81F3C43-BF92-B4D4-6662-2689916F7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BA32854-99FA-A54C-EBBA-3CC5E6600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E1C3E7B-301B-8AB4-BAF7-B6EF67094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0869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9233F9-9D28-09D0-99DB-5A83B4E97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D190E76-E7F3-377A-ABB0-5BB63FA3F7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A274189-E37B-21A4-50E5-37DD85E22B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11D3CC6-E818-A8DD-C240-4C8F34F75C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AA14AC1-1CD9-C163-E01D-3C5B6DFD03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58A70DF-4558-AACF-E50D-9396D31BC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693DD7F-F1DD-3408-B79C-B4E7FBF32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1997CF8-FC4A-083E-3B3F-9A2FD666B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3505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F263F7-32EF-72B3-51C3-034C3F54B9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6452712-75EB-0110-FD55-8CDEA5EB5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304E100-B906-D0F2-D2C2-9C6C54627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1357C4B-4D0B-1935-017C-DD4467D3B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961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BD62D74-22CA-97E4-842F-307D809A4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E8A7E31-1B81-64D9-BC9B-CE9210433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1E3918F-B59A-3EFA-7F86-40BB9D879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01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20BBED-2D6A-F4D8-75BB-38864839E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9ECE3AD-5A79-7051-ECFA-64A6016C1A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690D913-3D0A-2061-9130-9F5DAB834F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8410BF2-07FA-B307-F207-EFF74362D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6F4A1CC-9BB5-9F22-2FF8-154F2BA424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622F58D-7501-256A-CD3A-1250B2642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1577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C69C97-878B-EADE-E64D-ED0CDA9BC8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14E103A-3465-D0A0-B7C7-4065A1BE54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DDAE7A3-1EA2-471A-66C8-AC1D6B489D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7EF76AC-207C-8663-BB45-281D55485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45F4ED-EEA0-FB7B-B9EF-3731280C3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3F8C555-A433-3880-8569-A92A170D76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379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0955A3F-A57C-E65E-290F-30341C4D0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D10EEF0-A383-25DE-525B-DC1D349058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2EC8C8-2ADF-CA7D-9DF0-9611E4364E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2C163C-CABF-46BA-B68D-C4A598EF80B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1AA432-5173-666B-04AD-CA942810F0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20378F-F792-2DDE-D103-6A4B5D050A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92809D-5BA3-4884-8B04-CE11142496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0618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77B76586-1C62-99D4-4E1F-17222C565C4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23" t="38044" r="22011" b="35709"/>
          <a:stretch/>
        </p:blipFill>
        <p:spPr>
          <a:xfrm>
            <a:off x="3996024" y="2518231"/>
            <a:ext cx="5452770" cy="1874245"/>
          </a:xfrm>
          <a:prstGeom prst="rect">
            <a:avLst/>
          </a:prstGeom>
        </p:spPr>
      </p:pic>
      <p:grpSp>
        <p:nvGrpSpPr>
          <p:cNvPr id="3" name="Group 43">
            <a:extLst>
              <a:ext uri="{FF2B5EF4-FFF2-40B4-BE49-F238E27FC236}">
                <a16:creationId xmlns:a16="http://schemas.microsoft.com/office/drawing/2014/main" id="{15416560-2FB9-6966-7165-181B7EC3B9D5}"/>
              </a:ext>
            </a:extLst>
          </p:cNvPr>
          <p:cNvGrpSpPr/>
          <p:nvPr/>
        </p:nvGrpSpPr>
        <p:grpSpPr>
          <a:xfrm>
            <a:off x="2678261" y="1904370"/>
            <a:ext cx="7469103" cy="2070791"/>
            <a:chOff x="-1799860" y="6153712"/>
            <a:chExt cx="7469103" cy="2070791"/>
          </a:xfrm>
        </p:grpSpPr>
        <p:sp>
          <p:nvSpPr>
            <p:cNvPr id="4" name="文本框 31">
              <a:extLst>
                <a:ext uri="{FF2B5EF4-FFF2-40B4-BE49-F238E27FC236}">
                  <a16:creationId xmlns:a16="http://schemas.microsoft.com/office/drawing/2014/main" id="{FA20842E-A9D7-3E36-37D3-E65CC86719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20268" y="7946691"/>
              <a:ext cx="944217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ea typeface="黑体" panose="02010609060101010101" pitchFamily="49" charset="-122"/>
                  <a:cs typeface="Arial" panose="020B0604020202020204" pitchFamily="34" charset="0"/>
                </a:rPr>
                <a:t>His6</a:t>
              </a:r>
              <a:endParaRPr lang="zh-CN" altLang="en-US" sz="1200" dirty="0"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grpSp>
          <p:nvGrpSpPr>
            <p:cNvPr id="5" name="Group 152">
              <a:extLst>
                <a:ext uri="{FF2B5EF4-FFF2-40B4-BE49-F238E27FC236}">
                  <a16:creationId xmlns:a16="http://schemas.microsoft.com/office/drawing/2014/main" id="{3B425813-4E22-AF8D-AAD1-5F64C283A415}"/>
                </a:ext>
              </a:extLst>
            </p:cNvPr>
            <p:cNvGrpSpPr/>
            <p:nvPr/>
          </p:nvGrpSpPr>
          <p:grpSpPr>
            <a:xfrm>
              <a:off x="-1082038" y="6765411"/>
              <a:ext cx="661675" cy="276999"/>
              <a:chOff x="-858885" y="6632801"/>
              <a:chExt cx="661675" cy="276999"/>
            </a:xfrm>
          </p:grpSpPr>
          <p:sp>
            <p:nvSpPr>
              <p:cNvPr id="12" name="文本框 49">
                <a:extLst>
                  <a:ext uri="{FF2B5EF4-FFF2-40B4-BE49-F238E27FC236}">
                    <a16:creationId xmlns:a16="http://schemas.microsoft.com/office/drawing/2014/main" id="{CC521068-6F3C-36B1-4B0B-78E372468E75}"/>
                  </a:ext>
                </a:extLst>
              </p:cNvPr>
              <p:cNvSpPr txBox="1"/>
              <p:nvPr/>
            </p:nvSpPr>
            <p:spPr>
              <a:xfrm>
                <a:off x="-840899" y="6632801"/>
                <a:ext cx="6436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MW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直接连接符 63">
                <a:extLst>
                  <a:ext uri="{FF2B5EF4-FFF2-40B4-BE49-F238E27FC236}">
                    <a16:creationId xmlns:a16="http://schemas.microsoft.com/office/drawing/2014/main" id="{8D7DAACC-1800-042D-4E93-50CA388324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858885" y="6855791"/>
                <a:ext cx="457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" name="Group 153">
              <a:extLst>
                <a:ext uri="{FF2B5EF4-FFF2-40B4-BE49-F238E27FC236}">
                  <a16:creationId xmlns:a16="http://schemas.microsoft.com/office/drawing/2014/main" id="{7567DA28-8CF6-0DA4-D718-9A8072D1DA66}"/>
                </a:ext>
              </a:extLst>
            </p:cNvPr>
            <p:cNvGrpSpPr/>
            <p:nvPr/>
          </p:nvGrpSpPr>
          <p:grpSpPr>
            <a:xfrm>
              <a:off x="4979950" y="6786342"/>
              <a:ext cx="689293" cy="276999"/>
              <a:chOff x="7617180" y="6644793"/>
              <a:chExt cx="689293" cy="276999"/>
            </a:xfrm>
          </p:grpSpPr>
          <p:sp>
            <p:nvSpPr>
              <p:cNvPr id="10" name="文本框 49">
                <a:extLst>
                  <a:ext uri="{FF2B5EF4-FFF2-40B4-BE49-F238E27FC236}">
                    <a16:creationId xmlns:a16="http://schemas.microsoft.com/office/drawing/2014/main" id="{59548E4E-E894-EDF0-BDF6-78C13C066235}"/>
                  </a:ext>
                </a:extLst>
              </p:cNvPr>
              <p:cNvSpPr txBox="1"/>
              <p:nvPr/>
            </p:nvSpPr>
            <p:spPr>
              <a:xfrm>
                <a:off x="7662784" y="6644793"/>
                <a:ext cx="6436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Ab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1" name="直接连接符 63">
                <a:extLst>
                  <a:ext uri="{FF2B5EF4-FFF2-40B4-BE49-F238E27FC236}">
                    <a16:creationId xmlns:a16="http://schemas.microsoft.com/office/drawing/2014/main" id="{155786CD-CB36-4F69-6D6F-4A60E5DC0A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17180" y="6877634"/>
                <a:ext cx="457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文本框 29">
              <a:extLst>
                <a:ext uri="{FF2B5EF4-FFF2-40B4-BE49-F238E27FC236}">
                  <a16:creationId xmlns:a16="http://schemas.microsoft.com/office/drawing/2014/main" id="{4FD31903-1C16-54E1-8B5E-8FDEA42C1AC5}"/>
                </a:ext>
              </a:extLst>
            </p:cNvPr>
            <p:cNvSpPr txBox="1"/>
            <p:nvPr/>
          </p:nvSpPr>
          <p:spPr>
            <a:xfrm>
              <a:off x="-184143" y="6156010"/>
              <a:ext cx="196612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+       +          -         +     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+       -          +  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-       +          -         +</a:t>
              </a:r>
            </a:p>
          </p:txBody>
        </p:sp>
        <p:sp>
          <p:nvSpPr>
            <p:cNvPr id="8" name="文本框 29">
              <a:extLst>
                <a:ext uri="{FF2B5EF4-FFF2-40B4-BE49-F238E27FC236}">
                  <a16:creationId xmlns:a16="http://schemas.microsoft.com/office/drawing/2014/main" id="{30B805FA-E48B-6D06-08B0-86CAE975715B}"/>
                </a:ext>
              </a:extLst>
            </p:cNvPr>
            <p:cNvSpPr txBox="1"/>
            <p:nvPr/>
          </p:nvSpPr>
          <p:spPr>
            <a:xfrm>
              <a:off x="-1799860" y="6153712"/>
              <a:ext cx="166809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 beads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is-p53</a:t>
              </a:r>
              <a:r>
                <a:rPr lang="en-US" altLang="zh-CN" sz="1200" baseline="300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15-29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-CTD</a:t>
              </a:r>
            </a:p>
          </p:txBody>
        </p:sp>
        <p:cxnSp>
          <p:nvCxnSpPr>
            <p:cNvPr id="9" name="直接连接符 63">
              <a:extLst>
                <a:ext uri="{FF2B5EF4-FFF2-40B4-BE49-F238E27FC236}">
                  <a16:creationId xmlns:a16="http://schemas.microsoft.com/office/drawing/2014/main" id="{B0A2A5FB-418E-7655-E3AE-5D8B03754EDC}"/>
                </a:ext>
              </a:extLst>
            </p:cNvPr>
            <p:cNvCxnSpPr>
              <a:cxnSpLocks/>
            </p:cNvCxnSpPr>
            <p:nvPr/>
          </p:nvCxnSpPr>
          <p:spPr>
            <a:xfrm>
              <a:off x="-239024" y="6163267"/>
              <a:ext cx="19202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390ADE6A-DAFE-F1D9-F9D6-B2646EDF9578}"/>
              </a:ext>
            </a:extLst>
          </p:cNvPr>
          <p:cNvSpPr txBox="1"/>
          <p:nvPr/>
        </p:nvSpPr>
        <p:spPr>
          <a:xfrm>
            <a:off x="3414069" y="318598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D5BF560-CB0A-4394-679E-D9C8A1377034}"/>
              </a:ext>
            </a:extLst>
          </p:cNvPr>
          <p:cNvSpPr txBox="1"/>
          <p:nvPr/>
        </p:nvSpPr>
        <p:spPr>
          <a:xfrm>
            <a:off x="3414069" y="306322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6EDE800-BDDC-18B4-2035-3AB5DCB1C382}"/>
              </a:ext>
            </a:extLst>
          </p:cNvPr>
          <p:cNvSpPr txBox="1"/>
          <p:nvPr/>
        </p:nvSpPr>
        <p:spPr>
          <a:xfrm>
            <a:off x="3414069" y="330952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C46C197-E0B4-1E13-6E2A-FC1510115837}"/>
              </a:ext>
            </a:extLst>
          </p:cNvPr>
          <p:cNvSpPr txBox="1"/>
          <p:nvPr/>
        </p:nvSpPr>
        <p:spPr>
          <a:xfrm>
            <a:off x="3414069" y="350473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1B0BCEC-B561-8934-BC82-1C84E17F6D69}"/>
              </a:ext>
            </a:extLst>
          </p:cNvPr>
          <p:cNvSpPr txBox="1"/>
          <p:nvPr/>
        </p:nvSpPr>
        <p:spPr>
          <a:xfrm>
            <a:off x="3396083" y="379851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EAA7A9F-1161-91B9-2BDF-EE06068CB160}"/>
              </a:ext>
            </a:extLst>
          </p:cNvPr>
          <p:cNvSpPr txBox="1"/>
          <p:nvPr/>
        </p:nvSpPr>
        <p:spPr>
          <a:xfrm>
            <a:off x="3387222" y="404088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1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8BC42BA-66DA-6C3A-0FE2-97CD21FDF870}"/>
              </a:ext>
            </a:extLst>
          </p:cNvPr>
          <p:cNvSpPr txBox="1"/>
          <p:nvPr/>
        </p:nvSpPr>
        <p:spPr>
          <a:xfrm>
            <a:off x="3414069" y="292212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85243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4C2D0B3-17F4-2C6E-DC28-5B8A37EA5A9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20" t="26506" r="23141" b="43567"/>
          <a:stretch/>
        </p:blipFill>
        <p:spPr>
          <a:xfrm>
            <a:off x="4260867" y="1937091"/>
            <a:ext cx="5703509" cy="2396712"/>
          </a:xfrm>
          <a:prstGeom prst="rect">
            <a:avLst/>
          </a:prstGeom>
        </p:spPr>
      </p:pic>
      <p:grpSp>
        <p:nvGrpSpPr>
          <p:cNvPr id="5" name="Group 43">
            <a:extLst>
              <a:ext uri="{FF2B5EF4-FFF2-40B4-BE49-F238E27FC236}">
                <a16:creationId xmlns:a16="http://schemas.microsoft.com/office/drawing/2014/main" id="{980BB6DB-6CBE-E4FC-2F09-9871DF16AE76}"/>
              </a:ext>
            </a:extLst>
          </p:cNvPr>
          <p:cNvGrpSpPr/>
          <p:nvPr/>
        </p:nvGrpSpPr>
        <p:grpSpPr>
          <a:xfrm>
            <a:off x="2707289" y="1272998"/>
            <a:ext cx="8020644" cy="2525831"/>
            <a:chOff x="-1792603" y="6153712"/>
            <a:chExt cx="8020644" cy="2525831"/>
          </a:xfrm>
        </p:grpSpPr>
        <p:sp>
          <p:nvSpPr>
            <p:cNvPr id="6" name="文本框 31">
              <a:extLst>
                <a:ext uri="{FF2B5EF4-FFF2-40B4-BE49-F238E27FC236}">
                  <a16:creationId xmlns:a16="http://schemas.microsoft.com/office/drawing/2014/main" id="{4C2D27AE-43D7-BF80-451B-A1D708B79E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12243" y="8402544"/>
              <a:ext cx="94421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ea typeface="黑体" panose="02010609060101010101" pitchFamily="49" charset="-122"/>
                  <a:cs typeface="Arial" panose="020B0604020202020204" pitchFamily="34" charset="0"/>
                </a:rPr>
                <a:t>p53</a:t>
              </a:r>
            </a:p>
          </p:txBody>
        </p:sp>
        <p:grpSp>
          <p:nvGrpSpPr>
            <p:cNvPr id="7" name="Group 152">
              <a:extLst>
                <a:ext uri="{FF2B5EF4-FFF2-40B4-BE49-F238E27FC236}">
                  <a16:creationId xmlns:a16="http://schemas.microsoft.com/office/drawing/2014/main" id="{1E9834F6-2CA2-FCAD-C5CF-3EA88010CDB5}"/>
                </a:ext>
              </a:extLst>
            </p:cNvPr>
            <p:cNvGrpSpPr/>
            <p:nvPr/>
          </p:nvGrpSpPr>
          <p:grpSpPr>
            <a:xfrm>
              <a:off x="-781025" y="6765411"/>
              <a:ext cx="643689" cy="276999"/>
              <a:chOff x="-557872" y="6632801"/>
              <a:chExt cx="643689" cy="276999"/>
            </a:xfrm>
          </p:grpSpPr>
          <p:sp>
            <p:nvSpPr>
              <p:cNvPr id="14" name="文本框 49">
                <a:extLst>
                  <a:ext uri="{FF2B5EF4-FFF2-40B4-BE49-F238E27FC236}">
                    <a16:creationId xmlns:a16="http://schemas.microsoft.com/office/drawing/2014/main" id="{600D6FAD-B0B6-30E1-8ED2-54AC10FE5875}"/>
                  </a:ext>
                </a:extLst>
              </p:cNvPr>
              <p:cNvSpPr txBox="1"/>
              <p:nvPr/>
            </p:nvSpPr>
            <p:spPr>
              <a:xfrm>
                <a:off x="-557872" y="6632801"/>
                <a:ext cx="6436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MW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直接连接符 63">
                <a:extLst>
                  <a:ext uri="{FF2B5EF4-FFF2-40B4-BE49-F238E27FC236}">
                    <a16:creationId xmlns:a16="http://schemas.microsoft.com/office/drawing/2014/main" id="{E924468B-6F85-9AE9-C7A0-14E1BE2DCC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546829" y="6855791"/>
                <a:ext cx="457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" name="Group 153">
              <a:extLst>
                <a:ext uri="{FF2B5EF4-FFF2-40B4-BE49-F238E27FC236}">
                  <a16:creationId xmlns:a16="http://schemas.microsoft.com/office/drawing/2014/main" id="{C7A745A5-EB9A-19DC-B159-776AFCEAF999}"/>
                </a:ext>
              </a:extLst>
            </p:cNvPr>
            <p:cNvGrpSpPr/>
            <p:nvPr/>
          </p:nvGrpSpPr>
          <p:grpSpPr>
            <a:xfrm>
              <a:off x="5538750" y="6786342"/>
              <a:ext cx="689291" cy="276999"/>
              <a:chOff x="8175980" y="6644793"/>
              <a:chExt cx="689291" cy="276999"/>
            </a:xfrm>
          </p:grpSpPr>
          <p:sp>
            <p:nvSpPr>
              <p:cNvPr id="12" name="文本框 49">
                <a:extLst>
                  <a:ext uri="{FF2B5EF4-FFF2-40B4-BE49-F238E27FC236}">
                    <a16:creationId xmlns:a16="http://schemas.microsoft.com/office/drawing/2014/main" id="{7AFD1212-4ADB-DFB8-EBB4-B449BE89A032}"/>
                  </a:ext>
                </a:extLst>
              </p:cNvPr>
              <p:cNvSpPr txBox="1"/>
              <p:nvPr/>
            </p:nvSpPr>
            <p:spPr>
              <a:xfrm>
                <a:off x="8221582" y="6644793"/>
                <a:ext cx="6436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Ab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直接连接符 63">
                <a:extLst>
                  <a:ext uri="{FF2B5EF4-FFF2-40B4-BE49-F238E27FC236}">
                    <a16:creationId xmlns:a16="http://schemas.microsoft.com/office/drawing/2014/main" id="{2E12862B-7C2A-1D84-81CB-7424180833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75980" y="6877634"/>
                <a:ext cx="457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" name="文本框 29">
              <a:extLst>
                <a:ext uri="{FF2B5EF4-FFF2-40B4-BE49-F238E27FC236}">
                  <a16:creationId xmlns:a16="http://schemas.microsoft.com/office/drawing/2014/main" id="{8C40D09A-222F-9153-522D-09095CA7D476}"/>
                </a:ext>
              </a:extLst>
            </p:cNvPr>
            <p:cNvSpPr txBox="1"/>
            <p:nvPr/>
          </p:nvSpPr>
          <p:spPr>
            <a:xfrm>
              <a:off x="-184143" y="6156010"/>
              <a:ext cx="196612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+       +          -         +     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+       -          +  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-       +          -         +</a:t>
              </a:r>
            </a:p>
          </p:txBody>
        </p:sp>
        <p:sp>
          <p:nvSpPr>
            <p:cNvPr id="10" name="文本框 29">
              <a:extLst>
                <a:ext uri="{FF2B5EF4-FFF2-40B4-BE49-F238E27FC236}">
                  <a16:creationId xmlns:a16="http://schemas.microsoft.com/office/drawing/2014/main" id="{EB269E24-EE06-381E-C075-0EFEC25911BD}"/>
                </a:ext>
              </a:extLst>
            </p:cNvPr>
            <p:cNvSpPr txBox="1"/>
            <p:nvPr/>
          </p:nvSpPr>
          <p:spPr>
            <a:xfrm>
              <a:off x="-1792603" y="6153712"/>
              <a:ext cx="166809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 beads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is-p53</a:t>
              </a:r>
              <a:r>
                <a:rPr lang="en-US" altLang="zh-CN" sz="1200" baseline="300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15-29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-CTD</a:t>
              </a:r>
            </a:p>
          </p:txBody>
        </p:sp>
        <p:cxnSp>
          <p:nvCxnSpPr>
            <p:cNvPr id="11" name="直接连接符 63">
              <a:extLst>
                <a:ext uri="{FF2B5EF4-FFF2-40B4-BE49-F238E27FC236}">
                  <a16:creationId xmlns:a16="http://schemas.microsoft.com/office/drawing/2014/main" id="{0E8AAD9A-6E83-D941-30D2-92155FF609E5}"/>
                </a:ext>
              </a:extLst>
            </p:cNvPr>
            <p:cNvCxnSpPr>
              <a:cxnSpLocks/>
            </p:cNvCxnSpPr>
            <p:nvPr/>
          </p:nvCxnSpPr>
          <p:spPr>
            <a:xfrm>
              <a:off x="-239024" y="6163267"/>
              <a:ext cx="19202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文本框 15">
            <a:extLst>
              <a:ext uri="{FF2B5EF4-FFF2-40B4-BE49-F238E27FC236}">
                <a16:creationId xmlns:a16="http://schemas.microsoft.com/office/drawing/2014/main" id="{B6574487-1ED7-FC1D-5365-BB8B9C81A96A}"/>
              </a:ext>
            </a:extLst>
          </p:cNvPr>
          <p:cNvSpPr txBox="1"/>
          <p:nvPr/>
        </p:nvSpPr>
        <p:spPr>
          <a:xfrm>
            <a:off x="3559209" y="255460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449BD90-7345-3FC6-AA35-FCC8AB2204A7}"/>
              </a:ext>
            </a:extLst>
          </p:cNvPr>
          <p:cNvSpPr txBox="1"/>
          <p:nvPr/>
        </p:nvSpPr>
        <p:spPr>
          <a:xfrm>
            <a:off x="3559209" y="243185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69F7EA1-B61B-B86B-3D61-8C45CE945643}"/>
              </a:ext>
            </a:extLst>
          </p:cNvPr>
          <p:cNvSpPr txBox="1"/>
          <p:nvPr/>
        </p:nvSpPr>
        <p:spPr>
          <a:xfrm>
            <a:off x="3559209" y="267815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0A8E015-4440-3E28-B6AF-3B63D7F08AE5}"/>
              </a:ext>
            </a:extLst>
          </p:cNvPr>
          <p:cNvSpPr txBox="1"/>
          <p:nvPr/>
        </p:nvSpPr>
        <p:spPr>
          <a:xfrm>
            <a:off x="3559209" y="292416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549539F-C26A-F880-D14B-66C017C77F57}"/>
              </a:ext>
            </a:extLst>
          </p:cNvPr>
          <p:cNvSpPr txBox="1"/>
          <p:nvPr/>
        </p:nvSpPr>
        <p:spPr>
          <a:xfrm>
            <a:off x="3541223" y="324697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D2242F1-0900-EC14-F78D-F168D165877E}"/>
              </a:ext>
            </a:extLst>
          </p:cNvPr>
          <p:cNvSpPr txBox="1"/>
          <p:nvPr/>
        </p:nvSpPr>
        <p:spPr>
          <a:xfrm>
            <a:off x="3532362" y="350385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B4B4875-E087-D32E-D8AD-FAAB14258BEA}"/>
              </a:ext>
            </a:extLst>
          </p:cNvPr>
          <p:cNvSpPr txBox="1"/>
          <p:nvPr/>
        </p:nvSpPr>
        <p:spPr>
          <a:xfrm>
            <a:off x="3559209" y="229075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1759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Widescreen</PresentationFormat>
  <Paragraphs>3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 婷</dc:creator>
  <cp:lastModifiedBy>James su</cp:lastModifiedBy>
  <cp:revision>2</cp:revision>
  <dcterms:created xsi:type="dcterms:W3CDTF">2023-01-27T03:34:45Z</dcterms:created>
  <dcterms:modified xsi:type="dcterms:W3CDTF">2023-01-27T16:48:17Z</dcterms:modified>
</cp:coreProperties>
</file>